
<file path=[Content_Types].xml><?xml version="1.0" encoding="utf-8"?>
<Types xmlns="http://schemas.openxmlformats.org/package/2006/content-types">
  <Default Extension="avi" ContentType="video/x-msvideo"/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 autoCompressPictures="0">
  <p:sldMasterIdLst>
    <p:sldMasterId id="2147483648" r:id="rId1"/>
  </p:sldMasterIdLst>
  <p:sldIdLst>
    <p:sldId id="256" r:id="rId2"/>
    <p:sldId id="261" r:id="rId3"/>
    <p:sldId id="257" r:id="rId4"/>
    <p:sldId id="258" r:id="rId5"/>
    <p:sldId id="260" r:id="rId6"/>
  </p:sldIdLst>
  <p:sldSz cx="9144000" cy="6858000" type="screen4x3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>
        <p:scale>
          <a:sx n="135" d="100"/>
          <a:sy n="135" d="100"/>
        </p:scale>
        <p:origin x="1504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06687-3CD2-484E-933B-9E43B6CC5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D57C021F-CE00-7E45-BA12-891AD00D8FD8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A84E9B-3EE7-F645-8783-DA58CCFD5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2A39B3-F54B-DA4B-A97B-A2EC664D2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648A75-C1E7-424A-AE44-908D596AFEF0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3905843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DE7D87-F27E-844E-8AF8-C7AAAAE01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9A9F221-7DD1-B144-A8DA-33726D65A4B4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E311D3-96A5-E044-A80C-5784C843A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AAE6F8-2E4E-8146-A430-14DE6E4AD3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120B642-46B6-D94C-A3D4-29C3962684CE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1951394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BFA5D3-65C9-9D48-A1CB-D9FD4FBD5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6026E88-E615-AB4E-82CA-469153BFD4CD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890072-E813-6544-B799-98CA1BEF3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A9D57E-2868-C145-B05C-269DF0C0B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1F218D8-0FF5-064B-A7AD-1B965005E0BC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22571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EC719-91F1-E146-8AB4-416F242B1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1C698E1-3FA8-264E-9302-1E81C16FF508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29F538-B9A0-9F46-9620-D8F563039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2DEA3-D97E-A648-A33E-095B6BAFAE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0CA7711-CAA2-7746-B5D1-5BED5F541D56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1420335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7378E7-2D6F-1A4A-AC4E-9269B5AD4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1708371-1B72-D042-A29A-38E73EC02FD8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C26194-80F0-984D-9F93-2BF076DAA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CFE5DD-55E9-244E-8736-C52CAAAB2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D1DDF1-51EE-9F4D-B9AC-8F3004E53892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3112930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FE7E61C-F5AD-E445-9AB7-48EE6572A9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DEF6914-417B-A347-AE9B-83AB38C49894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C20D528-4F9B-0545-BDAA-BF7B79CE1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C66D010-CA1A-7C40-BD48-E43584BB8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522577-2D78-F746-8701-59C74E332BEE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4252734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D21F2C55-65D6-D94E-879B-C193D22FE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6C937B2-1D7F-0C48-B557-5827AF1CBE90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1A25B8BC-BDB6-304B-A9E1-0BCCCB6EA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958D146A-7BA1-8449-B528-FBD8435E8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0F17998-6600-3946-B6C4-C77B8546FD6D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391589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0A3063EB-A06F-BB42-89B7-FCF9C90FA1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A6B72DA-5BC5-A745-8B64-E67CFB98FBB1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8FFE1E6C-5E4E-2B40-9F19-D37F1CC09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D76C62A8-3D28-484B-9B64-C7DFD9E0E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4E32EA3-3E27-104B-9A7D-F84B712BEC4C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3973366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3B83CE54-FA1C-2E44-9DDE-6097E75D4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273EC49-9E90-2D45-BAEC-CA341B3FBFAE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212154FA-9B7C-F142-BE54-F72586E64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A212E192-3D1E-7144-9BE5-1D8CCBD7F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5FE58B-4466-CC48-B81F-60264FFF14AB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2435005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ck to edit Master text styles</a:t>
            </a:r>
          </a:p>
          <a:p>
            <a:pPr lvl="1"/>
            <a:r>
              <a:rPr lang="fr-FR"/>
              <a:t>Second level</a:t>
            </a:r>
          </a:p>
          <a:p>
            <a:pPr lvl="2"/>
            <a:r>
              <a:rPr lang="fr-FR"/>
              <a:t>Third level</a:t>
            </a:r>
          </a:p>
          <a:p>
            <a:pPr lvl="3"/>
            <a:r>
              <a:rPr lang="fr-FR"/>
              <a:t>Fourth level</a:t>
            </a:r>
          </a:p>
          <a:p>
            <a:pPr lvl="4"/>
            <a:r>
              <a:rPr lang="fr-FR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0DB3006-73B5-644E-8F26-6407008F6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5746320-44D9-D448-9B91-9E58871F6C9E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CCA1688D-A345-3A4C-9874-2E9C22457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EF80D57-1745-634E-A114-7D4F07EA29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777BCC1-DBBE-C34C-B28D-32142A2A500F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4133640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29DCFE7-C06D-654E-90FC-0ED031A32C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D355FCD-A059-A546-8607-3C4FE2979B1C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0E75D79-78BC-0440-B37F-94506BA11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880715E-6FAC-C149-ADF6-E725CC799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51EBFC8-F703-2D47-8908-1509BD83F3C0}" type="slidenum">
              <a:rPr lang="en-GB" altLang="fr-FR"/>
              <a:pPr/>
              <a:t>‹N°›</a:t>
            </a:fld>
            <a:endParaRPr lang="en-GB" altLang="fr-FR"/>
          </a:p>
        </p:txBody>
      </p:sp>
    </p:spTree>
    <p:extLst>
      <p:ext uri="{BB962C8B-B14F-4D97-AF65-F5344CB8AC3E}">
        <p14:creationId xmlns:p14="http://schemas.microsoft.com/office/powerpoint/2010/main" val="1543041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734F583A-E167-A841-B0BD-7BE80F433253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ck to edit Master title style</a:t>
            </a:r>
            <a:endParaRPr lang="en-GB" altLang="fr-FR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9AFEA712-48A7-7348-9ADF-DD1A491712A8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ck to edit Master text styles</a:t>
            </a:r>
          </a:p>
          <a:p>
            <a:pPr lvl="1"/>
            <a:r>
              <a:rPr lang="fr-FR" altLang="fr-FR"/>
              <a:t>Second level</a:t>
            </a:r>
          </a:p>
          <a:p>
            <a:pPr lvl="2"/>
            <a:r>
              <a:rPr lang="fr-FR" altLang="fr-FR"/>
              <a:t>Third level</a:t>
            </a:r>
          </a:p>
          <a:p>
            <a:pPr lvl="3"/>
            <a:r>
              <a:rPr lang="fr-FR" altLang="fr-FR"/>
              <a:t>Fourth level</a:t>
            </a:r>
          </a:p>
          <a:p>
            <a:pPr lvl="4"/>
            <a:r>
              <a:rPr lang="fr-FR" altLang="fr-FR"/>
              <a:t>Fifth level</a:t>
            </a:r>
            <a:endParaRPr lang="en-GB" alt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5F321C-559B-6A4A-8D30-A9286E1DE1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EE1BD52-8EA8-F04B-94D1-D8A120FF6838}" type="datetimeFigureOut">
              <a:rPr lang="en-US" altLang="fr-FR"/>
              <a:pPr/>
              <a:t>5/2/25</a:t>
            </a:fld>
            <a:endParaRPr lang="en-GB" alt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FA871C-7B2A-8A41-A7EB-42ED75B4C4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ED8064-73D2-CE46-A42C-97B8540F11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4FB56413-B4D2-DF4B-A6B6-6FEC258239CF}" type="slidenum">
              <a:rPr lang="en-GB" altLang="fr-FR"/>
              <a:pPr/>
              <a:t>‹N°›</a:t>
            </a:fld>
            <a:endParaRPr lang="en-GB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anose="020B0600070205080204" pitchFamily="34" charset="-128"/>
          <a:cs typeface="+mj-cs"/>
        </a:defRPr>
      </a:lvl1pPr>
      <a:lvl2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2pPr>
      <a:lvl3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3pPr>
      <a:lvl4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4pPr>
      <a:lvl5pPr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34" charset="-128"/>
        </a:defRPr>
      </a:lvl9pPr>
    </p:titleStyle>
    <p:bodyStyle>
      <a:lvl1pPr marL="342900" indent="-3429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panose="020B0600070205080204" pitchFamily="34" charset="-128"/>
          <a:cs typeface="+mn-cs"/>
        </a:defRPr>
      </a:lvl1pPr>
      <a:lvl2pPr marL="742950" indent="-28575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panose="020B0600070205080204" pitchFamily="34" charset="-128"/>
          <a:cs typeface="+mn-cs"/>
        </a:defRPr>
      </a:lvl2pPr>
      <a:lvl3pPr marL="11430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panose="020B0600070205080204" pitchFamily="34" charset="-128"/>
          <a:cs typeface="+mn-cs"/>
        </a:defRPr>
      </a:lvl3pPr>
      <a:lvl4pPr marL="16002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panose="020B0600070205080204" pitchFamily="34" charset="-128"/>
          <a:cs typeface="+mn-cs"/>
        </a:defRPr>
      </a:lvl4pPr>
      <a:lvl5pPr marL="2057400" indent="-228600" algn="l" defTabSz="457200" rtl="0" fontAlgn="base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ＭＳ Ｐゴシック" panose="020B0600070205080204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Document_Microsoft_Word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Document_Microsoft_Word1.doc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Box 2">
            <a:extLst>
              <a:ext uri="{FF2B5EF4-FFF2-40B4-BE49-F238E27FC236}">
                <a16:creationId xmlns:a16="http://schemas.microsoft.com/office/drawing/2014/main" id="{6A7FD561-5DA1-3C43-86BF-FECE8E453F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37050" y="406400"/>
            <a:ext cx="111918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GB" altLang="fr-FR" sz="2000" b="1"/>
              <a:t>Movie_1</a:t>
            </a:r>
          </a:p>
        </p:txBody>
      </p:sp>
      <p:pic>
        <p:nvPicPr>
          <p:cNvPr id="3" name="Média en ligne 2" descr="movie_chlamy_nakedeye_20fps.avi">
            <a:hlinkClick r:id="" action="ppaction://media"/>
            <a:extLst>
              <a:ext uri="{FF2B5EF4-FFF2-40B4-BE49-F238E27FC236}">
                <a16:creationId xmlns:a16="http://schemas.microsoft.com/office/drawing/2014/main" id="{DB79ECC4-B7E1-6F41-9F6C-D7989713A52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458449" y="1239391"/>
            <a:ext cx="3111500" cy="45847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58A93C15-5925-7845-BD36-00E83278CC7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65581"/>
              </p:ext>
            </p:extLst>
          </p:nvPr>
        </p:nvGraphicFramePr>
        <p:xfrm>
          <a:off x="2445249" y="191372"/>
          <a:ext cx="4232953" cy="6446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35" name="Document" r:id="rId3" imgW="5727700" imgH="8724900" progId="Word.Document.12">
                  <p:embed/>
                </p:oleObj>
              </mc:Choice>
              <mc:Fallback>
                <p:oleObj name="Document" r:id="rId3" imgW="5727700" imgH="87249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45249" y="191372"/>
                        <a:ext cx="4232953" cy="6446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42A8E53F-C0D3-F243-ADF6-49871D4DF788}"/>
              </a:ext>
            </a:extLst>
          </p:cNvPr>
          <p:cNvSpPr txBox="1"/>
          <p:nvPr/>
        </p:nvSpPr>
        <p:spPr>
          <a:xfrm>
            <a:off x="1006867" y="1705510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.S1</a:t>
            </a:r>
          </a:p>
        </p:txBody>
      </p:sp>
    </p:spTree>
    <p:extLst>
      <p:ext uri="{BB962C8B-B14F-4D97-AF65-F5344CB8AC3E}">
        <p14:creationId xmlns:p14="http://schemas.microsoft.com/office/powerpoint/2010/main" val="1026200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3" name="Group 1">
            <a:extLst>
              <a:ext uri="{FF2B5EF4-FFF2-40B4-BE49-F238E27FC236}">
                <a16:creationId xmlns:a16="http://schemas.microsoft.com/office/drawing/2014/main" id="{480E5543-4F5A-4E46-A04D-C58F38F81CFE}"/>
              </a:ext>
            </a:extLst>
          </p:cNvPr>
          <p:cNvGrpSpPr>
            <a:grpSpLocks/>
          </p:cNvGrpSpPr>
          <p:nvPr/>
        </p:nvGrpSpPr>
        <p:grpSpPr bwMode="auto">
          <a:xfrm>
            <a:off x="888999" y="776288"/>
            <a:ext cx="5943315" cy="5727700"/>
            <a:chOff x="963501" y="776288"/>
            <a:chExt cx="6131374" cy="5728301"/>
          </a:xfrm>
        </p:grpSpPr>
        <p:grpSp>
          <p:nvGrpSpPr>
            <p:cNvPr id="3075" name="Group 15">
              <a:extLst>
                <a:ext uri="{FF2B5EF4-FFF2-40B4-BE49-F238E27FC236}">
                  <a16:creationId xmlns:a16="http://schemas.microsoft.com/office/drawing/2014/main" id="{B278D3A3-0F57-0E4A-A72E-88FAC095DDD1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099773" y="776288"/>
              <a:ext cx="5995102" cy="4755499"/>
              <a:chOff x="483013" y="776675"/>
              <a:chExt cx="5995598" cy="4754838"/>
            </a:xfrm>
          </p:grpSpPr>
          <p:grpSp>
            <p:nvGrpSpPr>
              <p:cNvPr id="3077" name="Group 9">
                <a:extLst>
                  <a:ext uri="{FF2B5EF4-FFF2-40B4-BE49-F238E27FC236}">
                    <a16:creationId xmlns:a16="http://schemas.microsoft.com/office/drawing/2014/main" id="{BC126F01-5E79-1547-8932-D258F9AD7DB9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83013" y="776675"/>
                <a:ext cx="5995598" cy="4243572"/>
                <a:chOff x="483013" y="776675"/>
                <a:chExt cx="5995598" cy="4243572"/>
              </a:xfrm>
            </p:grpSpPr>
            <p:sp>
              <p:nvSpPr>
                <p:cNvPr id="3082" name="TextBox 2">
                  <a:extLst>
                    <a:ext uri="{FF2B5EF4-FFF2-40B4-BE49-F238E27FC236}">
                      <a16:creationId xmlns:a16="http://schemas.microsoft.com/office/drawing/2014/main" id="{6BC20D80-8413-7948-971E-4AF16F3ADF17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-128458" y="2468039"/>
                  <a:ext cx="1623085" cy="4001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 eaLnBrk="0" hangingPunct="0"/>
                  <a:r>
                    <a:rPr lang="en-GB" altLang="fr-FR" b="1"/>
                    <a:t>Dynamic signal</a:t>
                  </a:r>
                </a:p>
              </p:txBody>
            </p:sp>
            <p:grpSp>
              <p:nvGrpSpPr>
                <p:cNvPr id="3083" name="Group 8">
                  <a:extLst>
                    <a:ext uri="{FF2B5EF4-FFF2-40B4-BE49-F238E27FC236}">
                      <a16:creationId xmlns:a16="http://schemas.microsoft.com/office/drawing/2014/main" id="{46028D3B-7568-C14E-8419-6AB66BD3B909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889087" y="776675"/>
                  <a:ext cx="5589524" cy="4243572"/>
                  <a:chOff x="775012" y="776675"/>
                  <a:chExt cx="5589524" cy="4243572"/>
                </a:xfrm>
              </p:grpSpPr>
              <p:pic>
                <p:nvPicPr>
                  <p:cNvPr id="3084" name="Picture 1">
                    <a:extLst>
                      <a:ext uri="{FF2B5EF4-FFF2-40B4-BE49-F238E27FC236}">
                        <a16:creationId xmlns:a16="http://schemas.microsoft.com/office/drawing/2014/main" id="{91320BA2-5240-5D4B-9D68-48AE33EC46E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050" r="12099" b="9755"/>
                  <a:stretch>
                    <a:fillRect/>
                  </a:stretch>
                </p:blipFill>
                <p:spPr bwMode="auto">
                  <a:xfrm>
                    <a:off x="1699926" y="776675"/>
                    <a:ext cx="4664610" cy="424357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3085" name="TextBox 3">
                    <a:extLst>
                      <a:ext uri="{FF2B5EF4-FFF2-40B4-BE49-F238E27FC236}">
                        <a16:creationId xmlns:a16="http://schemas.microsoft.com/office/drawing/2014/main" id="{01062289-A600-B549-96D1-DA7F3DE1076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12439" y="4077369"/>
                    <a:ext cx="485668" cy="3077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r>
                      <a:rPr lang="en-GB" altLang="fr-FR" sz="1400"/>
                      <a:t>10k</a:t>
                    </a:r>
                  </a:p>
                </p:txBody>
              </p:sp>
              <p:sp>
                <p:nvSpPr>
                  <p:cNvPr id="3086" name="TextBox 4">
                    <a:extLst>
                      <a:ext uri="{FF2B5EF4-FFF2-40B4-BE49-F238E27FC236}">
                        <a16:creationId xmlns:a16="http://schemas.microsoft.com/office/drawing/2014/main" id="{BFA7255E-9D9B-314F-B1A7-99B0165921BA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19999" y="3378975"/>
                    <a:ext cx="485668" cy="58469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r>
                      <a:rPr lang="en-GB" altLang="fr-FR" sz="1400"/>
                      <a:t>20k</a:t>
                    </a:r>
                  </a:p>
                  <a:p>
                    <a:endParaRPr lang="en-GB" altLang="fr-FR"/>
                  </a:p>
                </p:txBody>
              </p:sp>
              <p:sp>
                <p:nvSpPr>
                  <p:cNvPr id="3087" name="Rectangle 5">
                    <a:extLst>
                      <a:ext uri="{FF2B5EF4-FFF2-40B4-BE49-F238E27FC236}">
                        <a16:creationId xmlns:a16="http://schemas.microsoft.com/office/drawing/2014/main" id="{2E1922C1-8180-7544-BFD0-7B1C1469E31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12909" y="2677716"/>
                    <a:ext cx="529643" cy="3077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r>
                      <a:rPr lang="en-GB" altLang="fr-FR" sz="1400"/>
                      <a:t> 30k</a:t>
                    </a:r>
                  </a:p>
                </p:txBody>
              </p:sp>
              <p:sp>
                <p:nvSpPr>
                  <p:cNvPr id="3088" name="Rectangle 6">
                    <a:extLst>
                      <a:ext uri="{FF2B5EF4-FFF2-40B4-BE49-F238E27FC236}">
                        <a16:creationId xmlns:a16="http://schemas.microsoft.com/office/drawing/2014/main" id="{A0FC96A9-4134-4845-8BA3-3503790DA4E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775012" y="1938092"/>
                    <a:ext cx="575206" cy="3077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r>
                      <a:rPr lang="en-GB" altLang="fr-FR" sz="1400"/>
                      <a:t>  40k</a:t>
                    </a:r>
                  </a:p>
                </p:txBody>
              </p:sp>
              <p:sp>
                <p:nvSpPr>
                  <p:cNvPr id="3089" name="Rectangle 7">
                    <a:extLst>
                      <a:ext uri="{FF2B5EF4-FFF2-40B4-BE49-F238E27FC236}">
                        <a16:creationId xmlns:a16="http://schemas.microsoft.com/office/drawing/2014/main" id="{3C1483DE-0299-C947-A941-36DF4896D71B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813771" y="1261180"/>
                    <a:ext cx="529643" cy="30773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5pPr>
                    <a:lvl6pPr marL="25146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6pPr>
                    <a:lvl7pPr marL="29718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7pPr>
                    <a:lvl8pPr marL="34290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8pPr>
                    <a:lvl9pPr marL="3886200" indent="-228600" defTabSz="4572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ＭＳ Ｐゴシック" panose="020B0600070205080204" pitchFamily="34" charset="-128"/>
                      </a:defRPr>
                    </a:lvl9pPr>
                  </a:lstStyle>
                  <a:p>
                    <a:r>
                      <a:rPr lang="en-GB" altLang="fr-FR" sz="1400"/>
                      <a:t> 50k</a:t>
                    </a:r>
                  </a:p>
                </p:txBody>
              </p:sp>
            </p:grpSp>
          </p:grpSp>
          <p:sp>
            <p:nvSpPr>
              <p:cNvPr id="3078" name="Rectangle 11">
                <a:extLst>
                  <a:ext uri="{FF2B5EF4-FFF2-40B4-BE49-F238E27FC236}">
                    <a16:creationId xmlns:a16="http://schemas.microsoft.com/office/drawing/2014/main" id="{9804502F-86E2-5D44-B755-5ED44D9906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7254" y="5020695"/>
                <a:ext cx="1118123" cy="3077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/>
                <a:r>
                  <a:rPr lang="en-GB" altLang="fr-FR" sz="1400"/>
                  <a:t>WT_455nm</a:t>
                </a:r>
              </a:p>
            </p:txBody>
          </p:sp>
          <p:sp>
            <p:nvSpPr>
              <p:cNvPr id="3079" name="TextBox 12">
                <a:extLst>
                  <a:ext uri="{FF2B5EF4-FFF2-40B4-BE49-F238E27FC236}">
                    <a16:creationId xmlns:a16="http://schemas.microsoft.com/office/drawing/2014/main" id="{66A8AEDF-51E8-8545-8FC6-8AA10A74077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925064" y="5008366"/>
                <a:ext cx="1118123" cy="3077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/>
                <a:r>
                  <a:rPr lang="en-GB" altLang="fr-FR" sz="1400"/>
                  <a:t>WT_505nm</a:t>
                </a:r>
              </a:p>
            </p:txBody>
          </p:sp>
          <p:sp>
            <p:nvSpPr>
              <p:cNvPr id="3080" name="TextBox 13">
                <a:extLst>
                  <a:ext uri="{FF2B5EF4-FFF2-40B4-BE49-F238E27FC236}">
                    <a16:creationId xmlns:a16="http://schemas.microsoft.com/office/drawing/2014/main" id="{DE0C4E60-5CCB-7C43-BAF5-20F01193B8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342114" y="5008366"/>
                <a:ext cx="753410" cy="5231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/>
                <a:r>
                  <a:rPr lang="en-GB" altLang="fr-FR" sz="1400"/>
                  <a:t>ΔrbcL</a:t>
                </a:r>
              </a:p>
              <a:p>
                <a:pPr algn="ctr"/>
                <a:r>
                  <a:rPr lang="en-GB" altLang="fr-FR" sz="1400"/>
                  <a:t>455nm</a:t>
                </a:r>
              </a:p>
            </p:txBody>
          </p:sp>
          <p:sp>
            <p:nvSpPr>
              <p:cNvPr id="3081" name="Rectangle 14">
                <a:extLst>
                  <a:ext uri="{FF2B5EF4-FFF2-40B4-BE49-F238E27FC236}">
                    <a16:creationId xmlns:a16="http://schemas.microsoft.com/office/drawing/2014/main" id="{4FFE7015-CE24-F141-B078-B0527337BA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89433" y="4998386"/>
                <a:ext cx="974045" cy="5232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algn="ctr"/>
                <a:r>
                  <a:rPr lang="en-GB" altLang="fr-FR" sz="1400"/>
                  <a:t>ΔrbcL</a:t>
                </a:r>
              </a:p>
              <a:p>
                <a:pPr algn="ctr"/>
                <a:r>
                  <a:rPr lang="en-GB" altLang="fr-FR" sz="1400"/>
                  <a:t>505nm</a:t>
                </a:r>
              </a:p>
            </p:txBody>
          </p:sp>
        </p:grpSp>
        <p:sp>
          <p:nvSpPr>
            <p:cNvPr id="3076" name="TextBox 18">
              <a:extLst>
                <a:ext uri="{FF2B5EF4-FFF2-40B4-BE49-F238E27FC236}">
                  <a16:creationId xmlns:a16="http://schemas.microsoft.com/office/drawing/2014/main" id="{95A299F4-32B3-FA49-856E-4675BABB6E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963501" y="5550482"/>
              <a:ext cx="6109476" cy="954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5pPr>
              <a:lvl6pPr marL="25146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6pPr>
              <a:lvl7pPr marL="29718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7pPr>
              <a:lvl8pPr marL="34290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8pPr>
              <a:lvl9pPr marL="3886200" indent="-228600" defTabSz="4572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ＭＳ Ｐゴシック" panose="020B0600070205080204" pitchFamily="34" charset="-128"/>
                </a:defRPr>
              </a:lvl9pPr>
            </a:lstStyle>
            <a:p>
              <a:r>
                <a:rPr lang="en-GB" altLang="fr-FR" sz="1400"/>
                <a:t>               Median               10668                3525                      29938               22238</a:t>
              </a:r>
            </a:p>
            <a:p>
              <a:r>
                <a:rPr lang="en-GB" altLang="fr-FR" sz="1400"/>
                <a:t>               Mean                   10627               3335                      30271               22881          </a:t>
              </a:r>
            </a:p>
          </p:txBody>
        </p:sp>
      </p:grpSp>
      <p:sp>
        <p:nvSpPr>
          <p:cNvPr id="3074" name="TextBox 19">
            <a:extLst>
              <a:ext uri="{FF2B5EF4-FFF2-40B4-BE49-F238E27FC236}">
                <a16:creationId xmlns:a16="http://schemas.microsoft.com/office/drawing/2014/main" id="{DB8C4F8F-3748-1541-B4E3-BF4F5BFC44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6538" y="266700"/>
            <a:ext cx="7270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fr-FR" altLang="fr-FR" dirty="0" err="1"/>
              <a:t>Fig</a:t>
            </a:r>
            <a:r>
              <a:rPr lang="fr-FR" altLang="fr-FR" dirty="0"/>
              <a:t> S2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TextBox 1">
            <a:extLst>
              <a:ext uri="{FF2B5EF4-FFF2-40B4-BE49-F238E27FC236}">
                <a16:creationId xmlns:a16="http://schemas.microsoft.com/office/drawing/2014/main" id="{EA27555A-0608-144B-9142-1883C0FF93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3488" y="150813"/>
            <a:ext cx="72707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fr-FR" altLang="fr-FR" dirty="0" err="1"/>
              <a:t>Fig</a:t>
            </a:r>
            <a:r>
              <a:rPr lang="fr-FR" altLang="fr-FR" dirty="0"/>
              <a:t> S3</a:t>
            </a:r>
          </a:p>
        </p:txBody>
      </p:sp>
      <p:grpSp>
        <p:nvGrpSpPr>
          <p:cNvPr id="18" name="Groupe 17">
            <a:extLst>
              <a:ext uri="{FF2B5EF4-FFF2-40B4-BE49-F238E27FC236}">
                <a16:creationId xmlns:a16="http://schemas.microsoft.com/office/drawing/2014/main" id="{F3AE2677-B9C5-CB4D-936B-584DD46395F4}"/>
              </a:ext>
            </a:extLst>
          </p:cNvPr>
          <p:cNvGrpSpPr/>
          <p:nvPr/>
        </p:nvGrpSpPr>
        <p:grpSpPr>
          <a:xfrm>
            <a:off x="130630" y="979714"/>
            <a:ext cx="9020569" cy="3626958"/>
            <a:chOff x="130630" y="979714"/>
            <a:chExt cx="9020569" cy="3626958"/>
          </a:xfrm>
        </p:grpSpPr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B95C4BCE-476A-984C-B017-D6CA411368FC}"/>
                </a:ext>
              </a:extLst>
            </p:cNvPr>
            <p:cNvGrpSpPr/>
            <p:nvPr/>
          </p:nvGrpSpPr>
          <p:grpSpPr>
            <a:xfrm>
              <a:off x="130630" y="979714"/>
              <a:ext cx="6005143" cy="3626958"/>
              <a:chOff x="63500" y="1069975"/>
              <a:chExt cx="9148696" cy="5660059"/>
            </a:xfrm>
          </p:grpSpPr>
          <p:pic>
            <p:nvPicPr>
              <p:cNvPr id="4099" name="Picture 12">
                <a:extLst>
                  <a:ext uri="{FF2B5EF4-FFF2-40B4-BE49-F238E27FC236}">
                    <a16:creationId xmlns:a16="http://schemas.microsoft.com/office/drawing/2014/main" id="{81A753F3-CBF1-FD47-ACF3-6E24D4794E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500" y="1069975"/>
                <a:ext cx="4508396" cy="490387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4100" name="Group 3">
                <a:extLst>
                  <a:ext uri="{FF2B5EF4-FFF2-40B4-BE49-F238E27FC236}">
                    <a16:creationId xmlns:a16="http://schemas.microsoft.com/office/drawing/2014/main" id="{51BF88C5-9605-5A43-9321-43E0126853F9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4571894" y="1069975"/>
                <a:ext cx="4640302" cy="4903870"/>
                <a:chOff x="6288162" y="1308200"/>
                <a:chExt cx="2838005" cy="2801938"/>
              </a:xfrm>
            </p:grpSpPr>
            <p:pic>
              <p:nvPicPr>
                <p:cNvPr id="4103" name="Picture 14">
                  <a:extLst>
                    <a:ext uri="{FF2B5EF4-FFF2-40B4-BE49-F238E27FC236}">
                      <a16:creationId xmlns:a16="http://schemas.microsoft.com/office/drawing/2014/main" id="{1277FBE0-00A3-8F45-BEA8-7186D7EA63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6288162" y="1308200"/>
                  <a:ext cx="2792412" cy="28019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6" name="Straight Connector 5">
                  <a:extLst>
                    <a:ext uri="{FF2B5EF4-FFF2-40B4-BE49-F238E27FC236}">
                      <a16:creationId xmlns:a16="http://schemas.microsoft.com/office/drawing/2014/main" id="{46EADB6F-B9BE-ED4E-B71C-205E8F396C22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>
                  <a:off x="8509743" y="4000579"/>
                  <a:ext cx="472892" cy="0"/>
                </a:xfrm>
                <a:prstGeom prst="line">
                  <a:avLst/>
                </a:prstGeom>
                <a:noFill/>
                <a:ln w="38100">
                  <a:solidFill>
                    <a:schemeClr val="tx1"/>
                  </a:solidFill>
                  <a:round/>
                  <a:headEnd/>
                  <a:tailEnd/>
                </a:ln>
                <a:effectLst>
                  <a:outerShdw blurRad="40000" dist="20000" dir="5400000" rotWithShape="0">
                    <a:srgbClr val="808080">
                      <a:alpha val="37999"/>
                    </a:srgbClr>
                  </a:outerShdw>
                </a:effectLst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sp>
              <p:nvSpPr>
                <p:cNvPr id="4105" name="TextBox 6">
                  <a:extLst>
                    <a:ext uri="{FF2B5EF4-FFF2-40B4-BE49-F238E27FC236}">
                      <a16:creationId xmlns:a16="http://schemas.microsoft.com/office/drawing/2014/main" id="{9CEE4E89-CA3B-1645-B4A0-74C3449D128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8366210" y="3631279"/>
                  <a:ext cx="759957" cy="3293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r>
                    <a:rPr lang="fr-FR" altLang="fr-FR" dirty="0"/>
                    <a:t>10 µm</a:t>
                  </a:r>
                </a:p>
              </p:txBody>
            </p:sp>
          </p:grpSp>
          <p:sp>
            <p:nvSpPr>
              <p:cNvPr id="4101" name="TextBox 7">
                <a:extLst>
                  <a:ext uri="{FF2B5EF4-FFF2-40B4-BE49-F238E27FC236}">
                    <a16:creationId xmlns:a16="http://schemas.microsoft.com/office/drawing/2014/main" id="{C0D1E9EE-6C0C-3047-B3EC-6547D53817B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80104" y="6153672"/>
                <a:ext cx="3013599" cy="576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r>
                  <a:rPr lang="fr-FR" altLang="fr-FR" dirty="0"/>
                  <a:t>Polarisation_</a:t>
                </a:r>
                <a:r>
                  <a:rPr lang="en-GB" i="1" dirty="0" err="1"/>
                  <a:t>ΔrbcL</a:t>
                </a:r>
                <a:r>
                  <a:rPr lang="fr-FR" dirty="0"/>
                  <a:t> </a:t>
                </a:r>
                <a:endParaRPr lang="fr-FR" altLang="fr-FR" dirty="0"/>
              </a:p>
            </p:txBody>
          </p:sp>
          <p:sp>
            <p:nvSpPr>
              <p:cNvPr id="4102" name="TextBox 8">
                <a:extLst>
                  <a:ext uri="{FF2B5EF4-FFF2-40B4-BE49-F238E27FC236}">
                    <a16:creationId xmlns:a16="http://schemas.microsoft.com/office/drawing/2014/main" id="{43BBEAC0-14CE-E949-8E0F-F4F196F79E6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853054" y="6153672"/>
                <a:ext cx="2787349" cy="3693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r>
                  <a:rPr lang="fr-FR" altLang="fr-FR" dirty="0"/>
                  <a:t>Bright </a:t>
                </a:r>
                <a:r>
                  <a:rPr lang="fr-FR" altLang="fr-FR" dirty="0" err="1"/>
                  <a:t>field</a:t>
                </a:r>
                <a:r>
                  <a:rPr lang="fr-FR" altLang="fr-FR" dirty="0"/>
                  <a:t> and polarisation</a:t>
                </a:r>
              </a:p>
            </p:txBody>
          </p:sp>
        </p:grpSp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1F0FCAB6-3E99-184D-BE3E-42C99B8A75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135773" y="983809"/>
              <a:ext cx="3015426" cy="3138297"/>
            </a:xfrm>
            <a:prstGeom prst="rect">
              <a:avLst/>
            </a:prstGeom>
          </p:spPr>
        </p:pic>
        <p:cxnSp>
          <p:nvCxnSpPr>
            <p:cNvPr id="7" name="Connecteur droit avec flèche 6">
              <a:extLst>
                <a:ext uri="{FF2B5EF4-FFF2-40B4-BE49-F238E27FC236}">
                  <a16:creationId xmlns:a16="http://schemas.microsoft.com/office/drawing/2014/main" id="{2696A5FF-49A7-F243-ABA5-46752803C3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975836" y="1574276"/>
              <a:ext cx="263950" cy="16968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avec flèche 18">
              <a:extLst>
                <a:ext uri="{FF2B5EF4-FFF2-40B4-BE49-F238E27FC236}">
                  <a16:creationId xmlns:a16="http://schemas.microsoft.com/office/drawing/2014/main" id="{D463AC9E-E593-AA44-B03C-5C353790802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32688" y="2037761"/>
              <a:ext cx="263950" cy="16968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avec flèche 19">
              <a:extLst>
                <a:ext uri="{FF2B5EF4-FFF2-40B4-BE49-F238E27FC236}">
                  <a16:creationId xmlns:a16="http://schemas.microsoft.com/office/drawing/2014/main" id="{151F50C5-0FA8-3642-9F7C-16788FAB86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22037" y="3684887"/>
              <a:ext cx="263950" cy="16968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avec flèche 20">
              <a:extLst>
                <a:ext uri="{FF2B5EF4-FFF2-40B4-BE49-F238E27FC236}">
                  <a16:creationId xmlns:a16="http://schemas.microsoft.com/office/drawing/2014/main" id="{2F047C1B-0762-7F48-AF6E-2C0F902984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37482" y="2260249"/>
              <a:ext cx="263950" cy="16968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cteur droit avec flèche 21">
              <a:extLst>
                <a:ext uri="{FF2B5EF4-FFF2-40B4-BE49-F238E27FC236}">
                  <a16:creationId xmlns:a16="http://schemas.microsoft.com/office/drawing/2014/main" id="{E57CB44A-08FB-4846-BFD6-12A5BCE1AFE4}"/>
                </a:ext>
              </a:extLst>
            </p:cNvPr>
            <p:cNvCxnSpPr>
              <a:cxnSpLocks/>
            </p:cNvCxnSpPr>
            <p:nvPr/>
          </p:nvCxnSpPr>
          <p:spPr>
            <a:xfrm>
              <a:off x="2658359" y="2705493"/>
              <a:ext cx="192598" cy="17968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avec flèche 24">
              <a:extLst>
                <a:ext uri="{FF2B5EF4-FFF2-40B4-BE49-F238E27FC236}">
                  <a16:creationId xmlns:a16="http://schemas.microsoft.com/office/drawing/2014/main" id="{07C1E98E-AF04-9B40-BCF9-69A25490C1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50957" y="1195632"/>
              <a:ext cx="61658" cy="272933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060FA48-5143-0445-886B-B48D7C0E3F6C}"/>
                </a:ext>
              </a:extLst>
            </p:cNvPr>
            <p:cNvSpPr/>
            <p:nvPr/>
          </p:nvSpPr>
          <p:spPr>
            <a:xfrm>
              <a:off x="6708501" y="4237340"/>
              <a:ext cx="164673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fr-FR" altLang="fr-FR" dirty="0" err="1"/>
                <a:t>Polarisation_wt</a:t>
              </a:r>
              <a:endParaRPr lang="fr-FR" altLang="fr-FR" dirty="0"/>
            </a:p>
          </p:txBody>
        </p:sp>
        <p:cxnSp>
          <p:nvCxnSpPr>
            <p:cNvPr id="29" name="Connecteur droit avec flèche 28">
              <a:extLst>
                <a:ext uri="{FF2B5EF4-FFF2-40B4-BE49-F238E27FC236}">
                  <a16:creationId xmlns:a16="http://schemas.microsoft.com/office/drawing/2014/main" id="{2F725DD6-830E-E34B-9A05-5A594F68560B}"/>
                </a:ext>
              </a:extLst>
            </p:cNvPr>
            <p:cNvCxnSpPr>
              <a:cxnSpLocks/>
            </p:cNvCxnSpPr>
            <p:nvPr/>
          </p:nvCxnSpPr>
          <p:spPr>
            <a:xfrm>
              <a:off x="8559538" y="2620652"/>
              <a:ext cx="182195" cy="20581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E7D54ED8-D0C4-3745-83FA-F3FF6A0F1B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45794593"/>
              </p:ext>
            </p:extLst>
          </p:nvPr>
        </p:nvGraphicFramePr>
        <p:xfrm>
          <a:off x="449971" y="1037690"/>
          <a:ext cx="8177897" cy="4315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3" name="Document" r:id="rId3" imgW="5969000" imgH="3149600" progId="Word.Document.12">
                  <p:embed/>
                </p:oleObj>
              </mc:Choice>
              <mc:Fallback>
                <p:oleObj name="Document" r:id="rId3" imgW="5969000" imgH="31496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9971" y="1037690"/>
                        <a:ext cx="8177897" cy="4315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62642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54</Words>
  <Application>Microsoft Macintosh PowerPoint</Application>
  <PresentationFormat>Affichage à l'écran (4:3)</PresentationFormat>
  <Paragraphs>22</Paragraphs>
  <Slides>5</Slides>
  <Notes>0</Notes>
  <HiddenSlides>0</HiddenSlides>
  <MMClips>1</MMClips>
  <ScaleCrop>false</ScaleCrop>
  <HeadingPairs>
    <vt:vector size="8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Office Theme</vt:lpstr>
      <vt:lpstr>Docume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e Boccara</dc:creator>
  <cp:lastModifiedBy>Martine Boccara</cp:lastModifiedBy>
  <cp:revision>7</cp:revision>
  <dcterms:created xsi:type="dcterms:W3CDTF">2024-12-12T15:44:13Z</dcterms:created>
  <dcterms:modified xsi:type="dcterms:W3CDTF">2025-05-02T12:22:38Z</dcterms:modified>
</cp:coreProperties>
</file>